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97E6C13-2DB0-4791-89A9-0D758B611198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752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88513BA-4E8C-4748-9E12-BB3E6F3DAC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584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7D3689F-3DEF-41D8-96BD-C5332B1E6B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08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844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08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844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F789932-8B1C-47F5-B52F-BF70303D9990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4E39FEB-2FDC-43B5-9CB4-32667BCD9B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BA4B388-CBD7-41FF-ACDE-82CB6F2632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80824A9-BF72-4018-A2DA-DF3A483440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A2AC551-05A0-47AA-B003-6A2F6493C18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4160" cy="6139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EC5D00A-7033-4C2F-A64B-B0220FF4958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9A9BF79-E6EE-4D03-9B89-BD1738598D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584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E42AA2E-06E1-46FA-A1FA-846EC64322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271CCAB-51CB-4C3A-9BCB-C2521D3F5F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1/30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86104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6651DD5B-7936-48A1-9FBB-4E77F9AEA04F}" type="slidenum">
              <a:rPr b="0" lang="en-US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925640" y="1123920"/>
          <a:ext cx="6202440" cy="2413080"/>
        </p:xfrm>
        <a:graphic>
          <a:graphicData uri="http://schemas.openxmlformats.org/drawingml/2006/table">
            <a:tbl>
              <a:tblPr/>
              <a:tblGrid>
                <a:gridCol w="932040"/>
                <a:gridCol w="3303360"/>
                <a:gridCol w="112680"/>
                <a:gridCol w="282600"/>
                <a:gridCol w="371520"/>
                <a:gridCol w="1200240"/>
              </a:tblGrid>
              <a:tr h="248040">
                <a:tc>
                  <a:txBody>
                    <a:bodyPr lIns="76680" rIns="7668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Prim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6680" marR="7668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76680" rIns="7668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Sequenc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6680" marR="766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gridSpan="3">
                  <a:txBody>
                    <a:bodyPr lIns="76680" rIns="7668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RE add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6680" marR="766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6680" rIns="7668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Orient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6680" marR="7668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</a:tr>
              <a:tr h="331560">
                <a:tc>
                  <a:txBody>
                    <a:bodyPr lIns="7920" rIns="7920" tIns="2376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7920" rIns="7920" tIns="2376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gridSpan="3">
                  <a:txBody>
                    <a:bodyPr lIns="7920" rIns="7920" tIns="2376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2376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13968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VP8* 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’-TTCGGACGCGTTCGTTCCATGGCTTCC-3’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gridSpan="3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Forwar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1400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VP8* 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’-GATCCATGGGAGCCCTCTGGTAAGTCACG-3’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gridSpan="3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Nco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Rever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1400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VP8*/6 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'- TTA CCG GTC ATG GCT TCC CTC ATC -3'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gridSpan="3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Age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Forwar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13968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VP8*/6 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'- GCT CGA GTC ATC ACT TCA CGA GCA 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gridSpan="3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Rever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7756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VP6/8*N 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’-TAT ATC ACC GGT ACC CCC </a:t>
                      </a:r>
                      <a:r>
                        <a:rPr b="0" lang="en-US" sz="9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Times New Roman"/>
                        </a:rPr>
                        <a:t>ATG GCT TCC CTC ATC TAC CGT CAG TTG CTC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GAT GTG CTC TAC TCC CTC TCC-3’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gridSpan="3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AgeI/Xho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Forwar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7792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VP6/8*N 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’-ACG AGG CCT ACG CTA TCC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TC GAG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TCA TCA CTT CAC GAG CAT GGA -3’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	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gridSpan="3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Xho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Rever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7828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VP6/8*C 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’-TAT CCC GGG TAT ATC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ACC GGT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TGA G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C ATG G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AT GTG CTC TAC TCC CTC TCC-3’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	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gridSpan="3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AgeI/Xho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Forwar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27792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VP6/8*C 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5’-TAT ATC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TC GAG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TCA TCA </a:t>
                      </a:r>
                      <a:r>
                        <a:rPr b="0" lang="en-US" sz="9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  <a:ea typeface="Times New Roman"/>
                        </a:rPr>
                        <a:t>GAG CAA CTG ACG GTA GAT GAG GGA AGC CAT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 CTT CAC GAG CAT GGA ACG-3’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	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gridSpan="3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Xho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Rever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</a:tr>
              <a:tr h="126000">
                <a:tc gridSpan="6"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*Underlined sequences represent VP8* epitop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6360">
                <a:tc>
                  <a:txBody>
                    <a:bodyPr lIns="7920" rIns="7920" tIns="828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 </a:t>
                      </a:r>
                      <a:endParaRPr b="0" lang="en-US" sz="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gridSpan="2">
                  <a:txBody>
                    <a:bodyPr lIns="7920" rIns="7920" tIns="792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gridSpan="2">
                  <a:txBody>
                    <a:bodyPr lIns="7920" rIns="7920" tIns="792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9cc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1925640" y="3538440"/>
            <a:ext cx="6095880" cy="960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 algn="just">
              <a:lnSpc>
                <a:spcPct val="150000"/>
              </a:lnSpc>
              <a:spcAft>
                <a:spcPts val="799"/>
              </a:spcAft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Calibri"/>
              </a:rPr>
              <a:t>Additional file 3: Table S1.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Calibri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Calibri"/>
              </a:rPr>
              <a:t>List of primer sequences used for rotavirus chimeric protein forma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